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48" d="100"/>
          <a:sy n="48" d="100"/>
        </p:scale>
        <p:origin x="-2192" y="-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662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00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4017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5402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078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0091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384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572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332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3584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6202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885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22101" y="1528050"/>
            <a:ext cx="6314283" cy="5914364"/>
            <a:chOff x="365168" y="678953"/>
            <a:chExt cx="6314283" cy="5914364"/>
          </a:xfrm>
        </p:grpSpPr>
        <p:grpSp>
          <p:nvGrpSpPr>
            <p:cNvPr id="3" name="组合 2"/>
            <p:cNvGrpSpPr/>
            <p:nvPr/>
          </p:nvGrpSpPr>
          <p:grpSpPr>
            <a:xfrm>
              <a:off x="365168" y="860414"/>
              <a:ext cx="6314283" cy="5732903"/>
              <a:chOff x="365168" y="212714"/>
              <a:chExt cx="6314283" cy="5732903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42703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4926" y="42703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2" name="图片 11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7852" y="42703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10779" y="42703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153668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4926" y="1536681"/>
                <a:ext cx="1440000" cy="1080000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436727" y="782370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0H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65168" y="1892015"/>
                <a:ext cx="418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2H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7852" y="153668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10779" y="153668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3475" y="264632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39243" y="2646326"/>
                <a:ext cx="1440000" cy="1080000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365168" y="4111305"/>
                <a:ext cx="418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36H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5011" y="264632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4" name="图片 23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10779" y="2646326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5" name="图片 24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375597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6" name="图片 25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4926" y="375597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7" name="图片 26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7852" y="375597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8" name="图片 27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10779" y="3755971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29" name="图片 28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4865617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30" name="图片 29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4926" y="4865617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31" name="图片 30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7852" y="4865617"/>
                <a:ext cx="1440000" cy="1080000"/>
              </a:xfrm>
              <a:prstGeom prst="rect">
                <a:avLst/>
              </a:prstGeom>
            </p:spPr>
          </p:pic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10779" y="4865617"/>
                <a:ext cx="1440000" cy="1080000"/>
              </a:xfrm>
              <a:prstGeom prst="rect">
                <a:avLst/>
              </a:prstGeom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365168" y="3001660"/>
                <a:ext cx="418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24H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65168" y="5220951"/>
                <a:ext cx="418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48H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35" name="矩形 34"/>
              <p:cNvSpPr/>
              <p:nvPr/>
            </p:nvSpPr>
            <p:spPr>
              <a:xfrm>
                <a:off x="879912" y="212714"/>
                <a:ext cx="12041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u</a:t>
                </a:r>
                <a:r>
                  <a:rPr lang="en-US" altLang="zh-CN" sz="1000" baseline="300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2+</a:t>
                </a:r>
                <a:r>
                  <a:rPr lang="en-US" altLang="zh-CN" sz="10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fluorescence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3842923" y="212714"/>
                <a:ext cx="120417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u</a:t>
                </a:r>
                <a:r>
                  <a:rPr lang="en-US" altLang="zh-CN" sz="1000" baseline="300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2+</a:t>
                </a:r>
                <a:r>
                  <a:rPr lang="en-US" altLang="zh-CN" sz="10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fluorescence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2244926" y="212714"/>
                <a:ext cx="14686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erged with brightfield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5210779" y="212714"/>
                <a:ext cx="146867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erged with brightfield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grpSp>
          <p:nvGrpSpPr>
            <p:cNvPr id="4" name="组合 3"/>
            <p:cNvGrpSpPr/>
            <p:nvPr/>
          </p:nvGrpSpPr>
          <p:grpSpPr>
            <a:xfrm>
              <a:off x="774484" y="678953"/>
              <a:ext cx="2880000" cy="246221"/>
              <a:chOff x="774484" y="596403"/>
              <a:chExt cx="2880000" cy="246221"/>
            </a:xfrm>
          </p:grpSpPr>
          <p:cxnSp>
            <p:nvCxnSpPr>
              <p:cNvPr id="8" name="直接连接符 7"/>
              <p:cNvCxnSpPr/>
              <p:nvPr/>
            </p:nvCxnSpPr>
            <p:spPr>
              <a:xfrm>
                <a:off x="774484" y="773014"/>
                <a:ext cx="288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1804679" y="596403"/>
                <a:ext cx="819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HeLa cells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grpSp>
          <p:nvGrpSpPr>
            <p:cNvPr id="5" name="组合 4"/>
            <p:cNvGrpSpPr/>
            <p:nvPr/>
          </p:nvGrpSpPr>
          <p:grpSpPr>
            <a:xfrm>
              <a:off x="3720884" y="678953"/>
              <a:ext cx="2880000" cy="246221"/>
              <a:chOff x="3720884" y="596403"/>
              <a:chExt cx="2880000" cy="246221"/>
            </a:xfrm>
          </p:grpSpPr>
          <p:cxnSp>
            <p:nvCxnSpPr>
              <p:cNvPr id="6" name="直接连接符 5"/>
              <p:cNvCxnSpPr/>
              <p:nvPr/>
            </p:nvCxnSpPr>
            <p:spPr>
              <a:xfrm>
                <a:off x="3720884" y="773014"/>
                <a:ext cx="288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4751079" y="596403"/>
                <a:ext cx="81961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SiHa cells</a:t>
                </a:r>
                <a:endParaRPr lang="zh-CN" altLang="en-US" sz="10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</p:grpSp>
      <p:pic>
        <p:nvPicPr>
          <p:cNvPr id="50" name="图片 49"/>
          <p:cNvPicPr preferRelativeResize="0">
            <a:picLocks/>
          </p:cNvPicPr>
          <p:nvPr/>
        </p:nvPicPr>
        <p:blipFill rotWithShape="1"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8391"/>
          <a:stretch/>
        </p:blipFill>
        <p:spPr>
          <a:xfrm>
            <a:off x="1168899" y="731368"/>
            <a:ext cx="144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TextBox 50"/>
          <p:cNvSpPr txBox="1"/>
          <p:nvPr/>
        </p:nvSpPr>
        <p:spPr>
          <a:xfrm>
            <a:off x="2619107" y="704607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FDX1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151538" y="49954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eL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509723" y="499542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aski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883939" y="499542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iH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214874" y="499542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33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94688" y="43318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57" name="图片 56"/>
          <p:cNvPicPr preferRelativeResize="0">
            <a:picLocks/>
          </p:cNvPicPr>
          <p:nvPr/>
        </p:nvPicPr>
        <p:blipFill rotWithShape="1">
          <a:blip r:embed="rId2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9497" b="4154"/>
          <a:stretch/>
        </p:blipFill>
        <p:spPr>
          <a:xfrm>
            <a:off x="1163939" y="951497"/>
            <a:ext cx="144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TextBox 57"/>
          <p:cNvSpPr txBox="1"/>
          <p:nvPr/>
        </p:nvSpPr>
        <p:spPr>
          <a:xfrm>
            <a:off x="2619107" y="920615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β-ACTIN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94688" y="122265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266327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</Words>
  <Application>Microsoft Office PowerPoint</Application>
  <PresentationFormat>全屏显示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2</cp:revision>
  <dcterms:created xsi:type="dcterms:W3CDTF">2024-02-29T09:19:42Z</dcterms:created>
  <dcterms:modified xsi:type="dcterms:W3CDTF">2024-02-29T09:21:27Z</dcterms:modified>
</cp:coreProperties>
</file>